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8168" autoAdjust="0"/>
  </p:normalViewPr>
  <p:slideViewPr>
    <p:cSldViewPr snapToGrid="0">
      <p:cViewPr>
        <p:scale>
          <a:sx n="100" d="100"/>
          <a:sy n="100" d="100"/>
        </p:scale>
        <p:origin x="1023" y="-57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93DAE-8E53-4500-995F-AECF631BB07E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C603E1-798A-443D-AF84-2F18FEC692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209102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93DAE-8E53-4500-995F-AECF631BB07E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C603E1-798A-443D-AF84-2F18FEC692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19200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93DAE-8E53-4500-995F-AECF631BB07E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C603E1-798A-443D-AF84-2F18FEC692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85758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93DAE-8E53-4500-995F-AECF631BB07E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C603E1-798A-443D-AF84-2F18FEC692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14632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93DAE-8E53-4500-995F-AECF631BB07E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C603E1-798A-443D-AF84-2F18FEC692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276198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93DAE-8E53-4500-995F-AECF631BB07E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C603E1-798A-443D-AF84-2F18FEC692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09364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93DAE-8E53-4500-995F-AECF631BB07E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C603E1-798A-443D-AF84-2F18FEC692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2315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93DAE-8E53-4500-995F-AECF631BB07E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C603E1-798A-443D-AF84-2F18FEC692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79635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93DAE-8E53-4500-995F-AECF631BB07E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C603E1-798A-443D-AF84-2F18FEC692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315206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93DAE-8E53-4500-995F-AECF631BB07E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C603E1-798A-443D-AF84-2F18FEC692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03509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93DAE-8E53-4500-995F-AECF631BB07E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C603E1-798A-443D-AF84-2F18FEC692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62244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393DAE-8E53-4500-995F-AECF631BB07E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C603E1-798A-443D-AF84-2F18FEC692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21510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25021" y="1116232"/>
            <a:ext cx="6832979" cy="950191"/>
          </a:xfrm>
        </p:spPr>
        <p:txBody>
          <a:bodyPr>
            <a:normAutofit/>
          </a:bodyPr>
          <a:lstStyle/>
          <a:p>
            <a:r>
              <a:rPr lang="en-US" altLang="zh-CN" sz="1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able A1 </a:t>
            </a:r>
            <a:r>
              <a:rPr lang="en-US" altLang="zh-CN" sz="18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ite No., location, distance to river, dominant species, production, </a:t>
            </a:r>
            <a:r>
              <a:rPr lang="en-US" altLang="zh-CN" sz="1800" dirty="0" smtClean="0">
                <a:solidFill>
                  <a:schemeClr val="accent4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PP</a:t>
            </a:r>
            <a:r>
              <a:rPr lang="en-US" altLang="zh-CN" sz="18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18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d LAI for three 2.5m×2.5m plots in summer of 2016.</a:t>
            </a:r>
            <a:endParaRPr lang="zh-CN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表格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83761"/>
              </p:ext>
            </p:extLst>
          </p:nvPr>
        </p:nvGraphicFramePr>
        <p:xfrm>
          <a:off x="34522" y="2508739"/>
          <a:ext cx="6714621" cy="2049983"/>
        </p:xfrm>
        <a:graphic>
          <a:graphicData uri="http://schemas.openxmlformats.org/drawingml/2006/table">
            <a:tbl>
              <a:tblPr firstRow="1" firstCol="1" bandRow="1"/>
              <a:tblGrid>
                <a:gridCol w="938641">
                  <a:extLst>
                    <a:ext uri="{9D8B030D-6E8A-4147-A177-3AD203B41FA5}">
                      <a16:colId xmlns:a16="http://schemas.microsoft.com/office/drawing/2014/main" val="1930259892"/>
                    </a:ext>
                  </a:extLst>
                </a:gridCol>
                <a:gridCol w="1191347">
                  <a:extLst>
                    <a:ext uri="{9D8B030D-6E8A-4147-A177-3AD203B41FA5}">
                      <a16:colId xmlns:a16="http://schemas.microsoft.com/office/drawing/2014/main" val="2229859907"/>
                    </a:ext>
                  </a:extLst>
                </a:gridCol>
                <a:gridCol w="969511">
                  <a:extLst>
                    <a:ext uri="{9D8B030D-6E8A-4147-A177-3AD203B41FA5}">
                      <a16:colId xmlns:a16="http://schemas.microsoft.com/office/drawing/2014/main" val="2656210507"/>
                    </a:ext>
                  </a:extLst>
                </a:gridCol>
                <a:gridCol w="985942">
                  <a:extLst>
                    <a:ext uri="{9D8B030D-6E8A-4147-A177-3AD203B41FA5}">
                      <a16:colId xmlns:a16="http://schemas.microsoft.com/office/drawing/2014/main" val="1800868695"/>
                    </a:ext>
                  </a:extLst>
                </a:gridCol>
                <a:gridCol w="1068104">
                  <a:extLst>
                    <a:ext uri="{9D8B030D-6E8A-4147-A177-3AD203B41FA5}">
                      <a16:colId xmlns:a16="http://schemas.microsoft.com/office/drawing/2014/main" val="263742006"/>
                    </a:ext>
                  </a:extLst>
                </a:gridCol>
                <a:gridCol w="1068105">
                  <a:extLst>
                    <a:ext uri="{9D8B030D-6E8A-4147-A177-3AD203B41FA5}">
                      <a16:colId xmlns:a16="http://schemas.microsoft.com/office/drawing/2014/main" val="3823572971"/>
                    </a:ext>
                  </a:extLst>
                </a:gridCol>
                <a:gridCol w="492971">
                  <a:extLst>
                    <a:ext uri="{9D8B030D-6E8A-4147-A177-3AD203B41FA5}">
                      <a16:colId xmlns:a16="http://schemas.microsoft.com/office/drawing/2014/main" val="71682719"/>
                    </a:ext>
                  </a:extLst>
                </a:gridCol>
              </a:tblGrid>
              <a:tr h="47848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Location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0764" marR="60764" marT="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000" kern="100" baseline="0" dirty="0" smtClea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istance to river (m)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0764" marR="60764" marT="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pecies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0764" marR="60764" marT="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roduction of leaf(g/m2</a:t>
                      </a:r>
                      <a:r>
                        <a:rPr lang="zh-CN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·</a:t>
                      </a: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)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0764" marR="60764" marT="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roduction of stem(g/m2</a:t>
                      </a:r>
                      <a:r>
                        <a:rPr lang="zh-CN" sz="10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·</a:t>
                      </a:r>
                      <a:r>
                        <a:rPr lang="en-US" sz="10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)</a:t>
                      </a:r>
                      <a:endParaRPr lang="zh-CN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0764" marR="60764" marT="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</a:t>
                      </a:r>
                      <a:r>
                        <a:rPr lang="en-US" altLang="zh-CN" sz="10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US" sz="10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P(g/m2</a:t>
                      </a:r>
                      <a:r>
                        <a:rPr lang="zh-CN" sz="10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·</a:t>
                      </a:r>
                      <a:r>
                        <a:rPr lang="en-US" sz="10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</a:t>
                      </a:r>
                      <a:r>
                        <a:rPr lang="en-US" sz="10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)</a:t>
                      </a:r>
                      <a:endParaRPr lang="zh-CN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0764" marR="60764" marT="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LAI</a:t>
                      </a:r>
                      <a:endParaRPr lang="zh-CN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0764" marR="60764" marT="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21385745"/>
                  </a:ext>
                </a:extLst>
              </a:tr>
              <a:tr h="540229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0</a:t>
                      </a:r>
                      <a:r>
                        <a:rPr lang="zh-CN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°</a:t>
                      </a: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32.842'N, 148</a:t>
                      </a:r>
                      <a:r>
                        <a:rPr lang="zh-CN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°</a:t>
                      </a: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5.113'E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0764" marR="60764" marT="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000" kern="100" dirty="0" smtClea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3 m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0764" marR="60764" marT="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i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alix </a:t>
                      </a:r>
                      <a:r>
                        <a:rPr lang="en-US" sz="1000" i="1" kern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oganidensis</a:t>
                      </a:r>
                      <a:endParaRPr lang="zh-CN" sz="1000" i="1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0764" marR="60764" marT="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85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0764" marR="60764" marT="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5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0764" marR="60764" marT="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10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0764" marR="60764" marT="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.59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0764" marR="60764" marT="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86052050"/>
                  </a:ext>
                </a:extLst>
              </a:tr>
              <a:tr h="50723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0</a:t>
                      </a:r>
                      <a:r>
                        <a:rPr lang="zh-CN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°</a:t>
                      </a: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38.355'N, 148</a:t>
                      </a:r>
                      <a:r>
                        <a:rPr lang="zh-CN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°</a:t>
                      </a: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8.851'E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0764" marR="6076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000" kern="100" dirty="0" smtClea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0</a:t>
                      </a:r>
                      <a:r>
                        <a:rPr lang="en-US" altLang="zh-CN" sz="1000" kern="100" baseline="0" dirty="0" smtClea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zh-CN" sz="1000" kern="100" dirty="0" smtClea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m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0764" marR="6076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i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alix </a:t>
                      </a:r>
                      <a:r>
                        <a:rPr lang="en-US" sz="1000" i="1" kern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ichardsonii</a:t>
                      </a:r>
                      <a:endParaRPr lang="zh-CN" sz="1000" i="1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0764" marR="6076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6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0764" marR="6076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1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0764" marR="6076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17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0764" marR="6076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71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0764" marR="6076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10880360"/>
                  </a:ext>
                </a:extLst>
              </a:tr>
              <a:tr h="52404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0</a:t>
                      </a:r>
                      <a:r>
                        <a:rPr lang="zh-CN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°</a:t>
                      </a: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33.592'N, 148</a:t>
                      </a:r>
                      <a:r>
                        <a:rPr lang="zh-CN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°</a:t>
                      </a: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7.746'E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0764" marR="6076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000" kern="100" dirty="0" smtClea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&gt;</a:t>
                      </a:r>
                      <a:r>
                        <a:rPr lang="en-US" altLang="zh-CN" sz="1000" kern="100" baseline="0" dirty="0" smtClea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zh-CN" sz="1000" kern="100" dirty="0" smtClea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30 m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0764" marR="6076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i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alix </a:t>
                      </a:r>
                      <a:r>
                        <a:rPr lang="en-US" sz="1000" i="1" kern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ulchra</a:t>
                      </a:r>
                      <a:endParaRPr lang="zh-CN" sz="1000" i="1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0764" marR="6076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51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0764" marR="6076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1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0764" marR="6076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63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0764" marR="6076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59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0764" marR="6076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5836425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488507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9</TotalTime>
  <Words>100</Words>
  <Application>Microsoft Office PowerPoint</Application>
  <PresentationFormat>A4 纸张(210x297 毫米)</PresentationFormat>
  <Paragraphs>2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Calibri Light</vt:lpstr>
      <vt:lpstr>Times New Roman</vt:lpstr>
      <vt:lpstr>Office 主题​​</vt:lpstr>
      <vt:lpstr>Table A1 Site No., location, distance to river, dominant species, production, ANPP, and LAI for three 2.5m×2.5m plots in summer of 2016.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 1 Map (Material part)</dc:title>
  <dc:creator>Rubing Fan</dc:creator>
  <cp:lastModifiedBy>Fan Rubing</cp:lastModifiedBy>
  <cp:revision>51</cp:revision>
  <dcterms:created xsi:type="dcterms:W3CDTF">2017-04-27T04:52:39Z</dcterms:created>
  <dcterms:modified xsi:type="dcterms:W3CDTF">2018-07-02T08:25:18Z</dcterms:modified>
</cp:coreProperties>
</file>